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694"/>
  </p:normalViewPr>
  <p:slideViewPr>
    <p:cSldViewPr snapToGrid="0">
      <p:cViewPr varScale="1">
        <p:scale>
          <a:sx n="121" d="100"/>
          <a:sy n="121" d="100"/>
        </p:scale>
        <p:origin x="7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C7CB4A-DEE3-4B28-9457-D1307768BE59}" type="datetimeFigureOut">
              <a:rPr lang="en-US" smtClean="0"/>
              <a:t>5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6B9CE9-682D-4A39-9074-11648D15A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76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6B9CE9-682D-4A39-9074-11648D15A6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184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C333A-D3B9-424B-A15B-5C668D70C1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EE63EB-58CA-4860-9EB8-10D4A02C92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0031C-7FCE-431D-8929-FB03DA0E3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ED1606-3956-456B-BD44-9E7267138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461429-DABC-46BC-8965-F49DB1A6D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524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C0194-C89B-4A91-93D0-B92C8EE4A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6900E9-F152-4C41-8A96-DD5C2C41B3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AE11D-46D7-429B-83A4-2F6F87334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BDE36-E9A7-4142-B177-8D7290552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1EB40-3FA3-461F-8C71-7952AD82C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337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552A70-9045-4766-9D77-AB31522999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FFBD72-C8DF-4B3D-ADAB-18B1D39221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0DFA7C-E48A-4F6F-BB6C-6F23B562D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A5B837-2B74-41B4-9822-807E8216F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D0178-16A1-4BBB-8BC9-E47049359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38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9CBD0-BB65-45D2-8B1A-37139A988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9C8B0F-76E4-4F36-A499-28161F7EA1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E52E7-AC83-4CB2-810D-A79231066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FB3AD5-B125-446C-9AC2-105AC7A79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723638-7066-4A80-A26C-9E2EDD5AC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180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D6850-E6C8-4B4C-B2BE-3E5DEE5BA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9B8847-5F89-46AA-9F6D-E2758BD057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C2C8AA-5AAA-417D-B7F9-3645EEDE4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CC5981-9C4E-4A7B-8F47-1C042A8FB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8E3959-0D53-44A6-B544-8E1462A8F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404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5F3D3-DFE4-4981-A13D-6DC60494D0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B41485-9D11-42AA-9F62-BE94EF4E15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D8ABB8-0DAF-4E1C-B01C-55D041BB00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23FB61-A4E7-4163-81FD-3F08CD8A4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2A1906-C3E9-40B5-A5BF-32FDB98E7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84D283-F683-438C-A697-265867930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125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86699-02FB-4715-975C-45C9E8635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2BCE50-0710-4ACE-835C-BE018E592C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48887A-1A0B-4E4E-ADEB-723D99CF1A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4784BA-1DD9-4B25-B2D0-46AE35E3ED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57A05A-4021-4C66-9202-A5BC871EA6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B9D62F-21AE-40A0-9856-72C81A56B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222F55-B0D0-4E29-B69D-FBE34275B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0FDD59-577E-4FC1-9D1A-78894F3F7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246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7764B-EA2F-4205-893C-3B27CD588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6A7693-CD95-4C65-A052-C17485A25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039DDA-385D-4263-A5AC-2A6507617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725994-E7FB-46F8-840D-4EEC7725D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66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A42566-D850-49E4-A488-DBC277D41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1C5EFD-24B1-422C-A23D-E0C035506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883C1A-3858-425B-A820-B8B35208C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907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78AE9-7FB0-4E73-9BDF-D99DE852F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D583E7-426B-41EE-977B-F045DA24CB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44A25D-ECAC-4EC7-966F-419524C168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EA741A-5488-4EED-B781-0A4F246E3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889457-F8BC-4A76-BC0D-7F84FC547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36B7EA-F3FC-4520-9B64-10D248279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81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DB0FA-8176-45DA-8846-708FDC6DA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9FDF1E5-A6A0-4556-89D3-1871B1252A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416BD1-E48E-41EB-83C6-23F4B615E7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7C2E6C-9D15-4A9E-B656-BEF384D62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1480F8-DE7A-47D1-9531-E1661E23A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505BFF-C9BD-4839-A16E-7870332FC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27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6832F8-AFA5-4DFF-AA5E-1F839B04A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1C3B34-694D-42A2-9EB4-D772EC1859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D45650-357B-478B-B2DF-D200F34961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42221-5089-4461-AE68-97F9A6CFB382}" type="datetimeFigureOut">
              <a:rPr lang="en-US" smtClean="0"/>
              <a:t>5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BDDE26-DA79-4FEB-9122-C2259E2814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C58A1-AE0B-404B-899E-F0F1CAAEA2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0FA0F-049B-4B6D-8A8F-1E4B2B9D9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541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9FFF5BC4-1D14-4F85-9D22-9093212EEAB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61463630"/>
              </p:ext>
            </p:extLst>
          </p:nvPr>
        </p:nvGraphicFramePr>
        <p:xfrm>
          <a:off x="585952" y="771224"/>
          <a:ext cx="10515600" cy="531555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4400">
                  <a:extLst>
                    <a:ext uri="{9D8B030D-6E8A-4147-A177-3AD203B41FA5}">
                      <a16:colId xmlns:a16="http://schemas.microsoft.com/office/drawing/2014/main" val="460596317"/>
                    </a:ext>
                  </a:extLst>
                </a:gridCol>
                <a:gridCol w="3818467">
                  <a:extLst>
                    <a:ext uri="{9D8B030D-6E8A-4147-A177-3AD203B41FA5}">
                      <a16:colId xmlns:a16="http://schemas.microsoft.com/office/drawing/2014/main" val="968819997"/>
                    </a:ext>
                  </a:extLst>
                </a:gridCol>
                <a:gridCol w="1576493">
                  <a:extLst>
                    <a:ext uri="{9D8B030D-6E8A-4147-A177-3AD203B41FA5}">
                      <a16:colId xmlns:a16="http://schemas.microsoft.com/office/drawing/2014/main" val="1599441624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3495921509"/>
                    </a:ext>
                  </a:extLst>
                </a:gridCol>
                <a:gridCol w="2103120">
                  <a:extLst>
                    <a:ext uri="{9D8B030D-6E8A-4147-A177-3AD203B41FA5}">
                      <a16:colId xmlns:a16="http://schemas.microsoft.com/office/drawing/2014/main" val="194426911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5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b="1" dirty="0" err="1"/>
                        <a:t>Mrwaniyeh</a:t>
                      </a:r>
                      <a:endParaRPr lang="en-US" sz="15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b="1" dirty="0" err="1"/>
                        <a:t>Abassiyeh</a:t>
                      </a:r>
                      <a:endParaRPr lang="en-US" sz="15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b="1" dirty="0"/>
                        <a:t>Ansa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b="1" dirty="0" err="1"/>
                        <a:t>Halba</a:t>
                      </a:r>
                      <a:endParaRPr lang="en-US" sz="15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87873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500" b="1" dirty="0"/>
                        <a:t>fertilization</a:t>
                      </a:r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Ammonium Sulfate (500 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Organic Matter (450 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Potassium Humate (5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Ferrous Sulfate (300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16-8-24 + S + Ca (10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Triple Super Phosphate (500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 Potassium Nitrate (225Kg/Year)</a:t>
                      </a:r>
                      <a:endParaRPr lang="en-US" sz="1500" dirty="0">
                        <a:effectLst/>
                      </a:endParaRPr>
                    </a:p>
                    <a:p>
                      <a:pPr marL="285750" marR="0" indent="-28575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 Magnesium Sulfate (500Kg/Year)</a:t>
                      </a:r>
                      <a:endParaRPr lang="en-US" sz="1500" dirty="0">
                        <a:effectLst/>
                      </a:endParaRPr>
                    </a:p>
                    <a:p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0" kern="1200" dirty="0">
                          <a:solidFill>
                            <a:schemeClr val="dk1"/>
                          </a:solidFill>
                          <a:effectLst/>
                        </a:rPr>
                        <a:t> 30-10-10 NPK foliar fertilizer (30 g/tree for young trees and 150g/tree for the aged ones each year);</a:t>
                      </a:r>
                    </a:p>
                    <a:p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No</a:t>
                      </a:r>
                      <a:r>
                        <a:rPr lang="en-US" sz="1500" dirty="0">
                          <a:solidFill>
                            <a:srgbClr val="FF0000"/>
                          </a:solidFill>
                        </a:rPr>
                        <a:t> </a:t>
                      </a:r>
                      <a:r>
                        <a:rPr lang="en-US" sz="1500" dirty="0">
                          <a:solidFill>
                            <a:schemeClr val="tx1"/>
                          </a:solidFill>
                        </a:rPr>
                        <a:t>fertilizers applied</a:t>
                      </a:r>
                    </a:p>
                  </a:txBody>
                  <a:tcPr marL="61814" marR="61814" marT="30908" marB="30908"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Boron each 4 month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0293305"/>
                  </a:ext>
                </a:extLst>
              </a:tr>
              <a:tr h="276478">
                <a:tc>
                  <a:txBody>
                    <a:bodyPr/>
                    <a:lstStyle/>
                    <a:p>
                      <a:r>
                        <a:rPr lang="en-US" sz="1500" b="1" dirty="0"/>
                        <a:t>pesticide</a:t>
                      </a:r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Abamectin 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Fosetyl-Al   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Chlorpyriphos (Not Approved in GAP)</a:t>
                      </a: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 Copper Oxychloride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500" dirty="0">
                          <a:solidFill>
                            <a:srgbClr val="323130"/>
                          </a:solidFill>
                          <a:effectLst/>
                        </a:rPr>
                        <a:t>July, august, September, October</a:t>
                      </a:r>
                      <a:endParaRPr lang="en-US" sz="1500" dirty="0"/>
                    </a:p>
                    <a:p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No pesticides mentioned</a:t>
                      </a:r>
                    </a:p>
                  </a:txBody>
                  <a:tcPr marL="61814" marR="61814" marT="30908" marB="30908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kern="1200" dirty="0">
                          <a:solidFill>
                            <a:schemeClr val="dk1"/>
                          </a:solidFill>
                          <a:effectLst/>
                        </a:rPr>
                        <a:t>Copper oxychloride (1 Kg /Dunam) </a:t>
                      </a:r>
                    </a:p>
                  </a:txBody>
                  <a:tcPr marL="61814" marR="61814" marT="30908" marB="30908"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No pesticides use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31669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500" b="1" dirty="0"/>
                        <a:t>irrigation</a:t>
                      </a:r>
                    </a:p>
                  </a:txBody>
                  <a:tcPr vert="vert27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kern="1200" dirty="0">
                          <a:solidFill>
                            <a:schemeClr val="dk1"/>
                          </a:solidFill>
                          <a:effectLst/>
                        </a:rPr>
                        <a:t>720 - 840 L/Tree each 10 days starting July till October</a:t>
                      </a:r>
                      <a:endParaRPr lang="en-US" sz="1500" dirty="0"/>
                    </a:p>
                    <a:p>
                      <a:endParaRPr lang="en-US" sz="15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500" kern="1200" dirty="0">
                          <a:solidFill>
                            <a:schemeClr val="dk1"/>
                          </a:solidFill>
                          <a:effectLst/>
                        </a:rPr>
                        <a:t>64 Liters per irrigation per tree every other day starting first June till October 10</a:t>
                      </a:r>
                      <a:endParaRPr lang="en-US" sz="1500" dirty="0"/>
                    </a:p>
                  </a:txBody>
                  <a:tcPr marL="61814" marR="61814" marT="30908" marB="30908"/>
                </a:tc>
                <a:tc>
                  <a:txBody>
                    <a:bodyPr/>
                    <a:lstStyle/>
                    <a:p>
                      <a:r>
                        <a:rPr lang="en-US" sz="1500" kern="1200" dirty="0">
                          <a:solidFill>
                            <a:schemeClr val="dk1"/>
                          </a:solidFill>
                          <a:effectLst/>
                        </a:rPr>
                        <a:t>180 Liters (0.18 m3) per Tree every six days starting first June till October</a:t>
                      </a:r>
                      <a:endParaRPr lang="en-US" sz="1500" dirty="0"/>
                    </a:p>
                  </a:txBody>
                  <a:tcPr marL="61814" marR="61814" marT="30908" marB="30908"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1-3 hours each 2 day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03597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091B835-0D03-2043-BC1C-70FDF0CF3C5D}"/>
              </a:ext>
            </a:extLst>
          </p:cNvPr>
          <p:cNvSpPr txBox="1"/>
          <p:nvPr/>
        </p:nvSpPr>
        <p:spPr>
          <a:xfrm>
            <a:off x="585952" y="94593"/>
            <a:ext cx="105155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Table S2: </a:t>
            </a:r>
            <a:r>
              <a:rPr lang="en-US" dirty="0"/>
              <a:t>The main agricultural practices applied by the GAP certified fields. The first three columns representing the south locations, and the last representing the north location.</a:t>
            </a:r>
          </a:p>
          <a:p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387230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16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s summarizing south fields results</dc:title>
  <dc:creator>Maya Salameh (Student)</dc:creator>
  <cp:lastModifiedBy>Walid El Kayal</cp:lastModifiedBy>
  <cp:revision>4</cp:revision>
  <dcterms:created xsi:type="dcterms:W3CDTF">2022-02-11T16:41:30Z</dcterms:created>
  <dcterms:modified xsi:type="dcterms:W3CDTF">2022-05-23T05:28:47Z</dcterms:modified>
</cp:coreProperties>
</file>